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149"/>
    <p:restoredTop sz="92790"/>
  </p:normalViewPr>
  <p:slideViewPr>
    <p:cSldViewPr snapToGrid="0" showGuides="1">
      <p:cViewPr>
        <p:scale>
          <a:sx n="150" d="100"/>
          <a:sy n="150" d="100"/>
        </p:scale>
        <p:origin x="4032" y="14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F55D84-A5BE-404B-8D40-2A6EFFCC4CDF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245799-3D68-5A42-AFBB-980A2F917A59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466638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245799-3D68-5A42-AFBB-980A2F917A59}" type="slidenum">
              <a:rPr kumimoji="1" lang="ko-KR" altLang="en-US" smtClean="0"/>
              <a:t>1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844232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88C01A-744E-CF66-08B8-0ED7569A9C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65CD72D-89B1-D7A7-0E6E-5F81AA1C52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4EA75-F677-4918-0A6C-997A86C62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8F26650-2DA6-139F-9630-797D2F897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D760F84-CDAC-99FD-D315-F3CFD10D4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28837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DD96390-5454-9AF3-4629-2392377218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C72FD6D-D74C-33A2-7DAF-5AA0408629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21A4321-C109-6A24-FD41-B221A057F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1A0AAF7-F9B6-1382-7DEF-61E5D529E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067AD8-E98B-DFB7-C667-178090EEA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4259853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B63C51B-A73B-0A72-C638-3E974CC407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2DD3EF8-D8AF-DB4D-3E17-DBC5FAB2C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2DC105-88F2-C9CF-A6E2-E90089F83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62536D3-915F-75EF-D8B4-5A45598DE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55758F5-4FBC-B85E-E07D-4AAB3C96B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214652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822FB6B-DE7D-801B-1F7D-276A28301D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6902D2B-BEA7-CC13-19AF-7B14ED3C61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A79D4E8-55D6-9A7C-5585-D0CAC78B4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5E2B278-2ECE-BDB4-0094-CE3C20A7C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4B64952-AB04-1B03-A7CD-741987775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15514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BFCAB7-616C-73AF-BFB1-ADC2B42E9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D7736D4-4B99-63D1-DA77-4CCF63E6C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4917742-757D-9BE8-6CAA-B9420C956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0888FAE-73F1-16E5-3E3D-963671B15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7500F6F-1916-E113-B56C-AEED14C35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8959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2B71B3-93E0-5078-0183-0546CE8C3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F9057E6-D409-AB1E-F9A7-F78A7E27A5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37D6B4F-F951-B91B-BF93-7F52321BA1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24870FD-C96E-9899-8941-D2B982EF5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68259CF-AB69-4775-4C7E-70322572F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21EF3D6-FBCC-3585-D5EF-FBF3D3CB2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025057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0137F0D-FE6D-F5B3-5249-B15A5BBD13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964CAF5-9EF0-E413-69B1-8EA5E189D7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21526FD-72E3-3714-0DB5-95CBCEF80C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A361B06-FE2E-297D-D465-D00B21970D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11BF33C-4BF0-1B4F-0B17-866B241AF5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E3E0E84-1F67-AAA3-6B36-B33FCF656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CCA224C-4904-6691-D4B6-A4FA0FD83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D7427B1-6E31-C60C-B4DD-A107F0E04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663994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F9C834-D8A2-0275-2919-CE32406BE9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B67762F-A6A4-BE51-28A0-9E53CBAA5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104C517-2A75-DEFC-554D-BD141EF66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F8B1857-B313-72D4-BE73-C0798EBF6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985964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10BFE32-E614-38DD-FDCF-406973B00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24D82C-B1E2-7AB0-9CF2-CEA0A9A39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440B21C-6E35-20EB-9E91-6F6B61B65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180907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C2F57B9-C19D-DCA3-BB1A-8FD5FAEA1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5B61F78-CFE0-ECB2-23A4-BA88CEFDB9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4F2EEBA-20E1-0938-CCF9-8EABDD8D93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62CFAE8-C539-8192-1A88-70F6005B9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FB1A669-C0FC-D1C4-AB48-A51F2F529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935D04-19D5-660C-6952-6F4BDCF95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499308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6DD7F03-4B7F-8551-F2F7-254E2B53C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C51BED8-2F27-CFB8-C4CC-FC55FCB780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6DCCA90-0CA7-03CD-848C-1FF7ECBAD4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1EB099B-A6D7-0921-82F3-4C01157BB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9983C49-89A4-5DC4-FF78-8F799E923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F3F4CBC-D90F-BBDC-02DF-4605F4292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57610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55F3C3E-7391-ED2B-0B43-8A6467719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70228E6-731F-5773-255F-B54C05722C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6B80F6-40D4-BF23-F548-3E7FBFC720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EA7039-86E8-FB42-8799-8FDC152892AA}" type="datetimeFigureOut">
              <a:rPr kumimoji="1" lang="ko-KR" altLang="en-US" smtClean="0"/>
              <a:t>2024. 10. 13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756E17-6019-3B09-4F85-9950E1F461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46B738A-313D-5773-FCDE-C78C1A2FCC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D6DCAA-F3FE-A94B-9830-4181FA218401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71822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>
            <a:extLst>
              <a:ext uri="{FF2B5EF4-FFF2-40B4-BE49-F238E27FC236}">
                <a16:creationId xmlns:a16="http://schemas.microsoft.com/office/drawing/2014/main" id="{A11D16EE-1B06-B69A-5573-32145CF60E94}"/>
              </a:ext>
            </a:extLst>
          </p:cNvPr>
          <p:cNvGrpSpPr/>
          <p:nvPr/>
        </p:nvGrpSpPr>
        <p:grpSpPr>
          <a:xfrm>
            <a:off x="630430" y="208715"/>
            <a:ext cx="10903164" cy="5672603"/>
            <a:chOff x="551563" y="410595"/>
            <a:chExt cx="10903164" cy="5672603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76AF5ACC-BE00-D458-9B6D-16DF166DAC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3551" t="11462" r="13909" b="65824"/>
            <a:stretch/>
          </p:blipFill>
          <p:spPr>
            <a:xfrm>
              <a:off x="704009" y="3799797"/>
              <a:ext cx="5153170" cy="228340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FD92C6D-1BE6-90F7-6154-AB4F992B6DDB}"/>
                </a:ext>
              </a:extLst>
            </p:cNvPr>
            <p:cNvSpPr txBox="1"/>
            <p:nvPr/>
          </p:nvSpPr>
          <p:spPr>
            <a:xfrm>
              <a:off x="8265589" y="410595"/>
              <a:ext cx="164019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ko-KR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IK3CA</a:t>
              </a:r>
              <a:r>
                <a:rPr kumimoji="1"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wild-type</a:t>
              </a:r>
              <a:endParaRPr kumimoji="1"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5C57A1B-E142-9647-A733-EDA49D0DFB64}"/>
                </a:ext>
              </a:extLst>
            </p:cNvPr>
            <p:cNvSpPr txBox="1"/>
            <p:nvPr/>
          </p:nvSpPr>
          <p:spPr>
            <a:xfrm>
              <a:off x="555903" y="564485"/>
              <a:ext cx="30489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D66519E-C65F-B118-D30B-2D6C3245BB83}"/>
                </a:ext>
              </a:extLst>
            </p:cNvPr>
            <p:cNvSpPr txBox="1"/>
            <p:nvPr/>
          </p:nvSpPr>
          <p:spPr>
            <a:xfrm>
              <a:off x="2128484" y="410595"/>
              <a:ext cx="264367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ko-KR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IK3CA</a:t>
              </a:r>
              <a:r>
                <a:rPr kumimoji="1"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(H1047R) mutant-type</a:t>
              </a:r>
              <a:endParaRPr kumimoji="1"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C619325-16F9-0ABD-A1AE-89B07449197F}"/>
                </a:ext>
              </a:extLst>
            </p:cNvPr>
            <p:cNvSpPr txBox="1"/>
            <p:nvPr/>
          </p:nvSpPr>
          <p:spPr>
            <a:xfrm>
              <a:off x="551563" y="3371403"/>
              <a:ext cx="30489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5133F4CB-59AA-D5A4-9D6E-49F37FBF9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3736" t="11521" r="13908" b="65824"/>
            <a:stretch/>
          </p:blipFill>
          <p:spPr>
            <a:xfrm>
              <a:off x="708349" y="966642"/>
              <a:ext cx="5153170" cy="2283401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C7A5E5F4-D48F-1A85-1631-F5BABF9C372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4324" t="11117" r="12446" b="65824"/>
            <a:stretch/>
          </p:blipFill>
          <p:spPr>
            <a:xfrm>
              <a:off x="6330483" y="962719"/>
              <a:ext cx="5124244" cy="2283401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27AB0FFD-951B-D1E2-F79E-B0563B9D3668}"/>
              </a:ext>
            </a:extLst>
          </p:cNvPr>
          <p:cNvSpPr txBox="1"/>
          <p:nvPr/>
        </p:nvSpPr>
        <p:spPr>
          <a:xfrm>
            <a:off x="878774" y="623454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ko-KR" alt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4FFCE1-C024-4E35-9530-740C55786F1E}"/>
              </a:ext>
            </a:extLst>
          </p:cNvPr>
          <p:cNvSpPr txBox="1"/>
          <p:nvPr/>
        </p:nvSpPr>
        <p:spPr>
          <a:xfrm>
            <a:off x="878774" y="5983329"/>
            <a:ext cx="1043445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Analysis of </a:t>
            </a:r>
            <a:r>
              <a:rPr lang="en-US" altLang="ko-KR" sz="1100" i="1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PIK3CA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(H1047R) mutation by Droplet Digital PCR assay in FFPE tissue samples. Representative 1-D plots of </a:t>
            </a:r>
            <a:r>
              <a:rPr lang="en-US" altLang="ko-KR" sz="1100" kern="100" dirty="0" err="1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ddPCR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for </a:t>
            </a:r>
            <a:r>
              <a:rPr lang="en-US" altLang="ko-KR" sz="1100" i="1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PIK3CA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(H1047R) mutation positive droplets (left) and </a:t>
            </a:r>
            <a:r>
              <a:rPr lang="en-US" altLang="ko-KR" sz="1100" i="1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PIK3CA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wild type droplets (right) in CMT tissue sample (Sample No. 6) (A) </a:t>
            </a:r>
            <a:r>
              <a:rPr lang="en-US" altLang="ko-KR" sz="1100" kern="100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and a 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non-neoplastic tissue sample (B). The droplets above the pink line, which is the threshold, are classified as positive (colored). Reactions with more than 8,000 droplets were considered valid.</a:t>
            </a:r>
            <a:endParaRPr lang="ko-KR" altLang="ko-KR" sz="1100" kern="100" dirty="0">
              <a:effectLst/>
              <a:latin typeface="Calibri" panose="020F0502020204030204" pitchFamily="34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83FECD5-2E4E-FFC2-27BF-5832AA8242D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2459" t="10889" r="12263" b="67068"/>
          <a:stretch/>
        </p:blipFill>
        <p:spPr>
          <a:xfrm>
            <a:off x="6261651" y="3597917"/>
            <a:ext cx="5277638" cy="2186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66244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E8BCCCB6-00A1-3247-83AB-D2E1D6A0A4B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543" t="11539" r="15264" b="64834"/>
          <a:stretch/>
        </p:blipFill>
        <p:spPr>
          <a:xfrm>
            <a:off x="6481465" y="3541764"/>
            <a:ext cx="5198824" cy="2476409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96C809C7-B201-BBFC-8468-35599C3C648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948" t="11328" r="16002" b="65249"/>
          <a:stretch/>
        </p:blipFill>
        <p:spPr>
          <a:xfrm>
            <a:off x="782876" y="760839"/>
            <a:ext cx="5124244" cy="245983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270B9F-EF39-D280-AEFA-77E46FFD59D2}"/>
              </a:ext>
            </a:extLst>
          </p:cNvPr>
          <p:cNvSpPr txBox="1"/>
          <p:nvPr/>
        </p:nvSpPr>
        <p:spPr>
          <a:xfrm>
            <a:off x="634770" y="362605"/>
            <a:ext cx="30489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ECC9A0-930B-90B7-D6B1-03E1B752A03F}"/>
              </a:ext>
            </a:extLst>
          </p:cNvPr>
          <p:cNvSpPr txBox="1"/>
          <p:nvPr/>
        </p:nvSpPr>
        <p:spPr>
          <a:xfrm>
            <a:off x="630430" y="3169523"/>
            <a:ext cx="30489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D35EB7B5-588D-8553-1C31-5CEB70122F6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5365" t="12050" r="15294" b="65667"/>
          <a:stretch/>
        </p:blipFill>
        <p:spPr>
          <a:xfrm>
            <a:off x="782876" y="3597917"/>
            <a:ext cx="5198824" cy="2364104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6466FB8E-07FA-9BFA-F035-87B0A86E04C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3079" t="11974" r="14959" b="65380"/>
          <a:stretch/>
        </p:blipFill>
        <p:spPr>
          <a:xfrm>
            <a:off x="6284882" y="817843"/>
            <a:ext cx="5395407" cy="240282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2E40F52-D1D6-2F08-5512-45D05CA270FA}"/>
              </a:ext>
            </a:extLst>
          </p:cNvPr>
          <p:cNvSpPr txBox="1"/>
          <p:nvPr/>
        </p:nvSpPr>
        <p:spPr>
          <a:xfrm>
            <a:off x="2207351" y="208715"/>
            <a:ext cx="264367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ko-KR" sz="1400" i="1" dirty="0">
                <a:latin typeface="Arial" panose="020B0604020202020204" pitchFamily="34" charset="0"/>
                <a:cs typeface="Arial" panose="020B0604020202020204" pitchFamily="34" charset="0"/>
              </a:rPr>
              <a:t>PIK3CA</a:t>
            </a:r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(H1047R) mutant-typ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83CD7CC-B83B-8681-00EB-71F3030BEBDE}"/>
              </a:ext>
            </a:extLst>
          </p:cNvPr>
          <p:cNvSpPr txBox="1"/>
          <p:nvPr/>
        </p:nvSpPr>
        <p:spPr>
          <a:xfrm>
            <a:off x="878774" y="5983329"/>
            <a:ext cx="1043445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Analysis of PIK3CA (H1047R) mutation by Droplet Digital PCR assay in blood samples. Representative 1-D plots of </a:t>
            </a:r>
            <a:r>
              <a:rPr lang="en-US" altLang="ko-KR" sz="1100" kern="100" dirty="0" err="1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ddPCR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 for PIK3CA (H1047R) mutation positive droplets (left) and PIK3CA wild type droplets (right) from the serum of a CMT patient (Sample No. </a:t>
            </a:r>
            <a:r>
              <a:rPr lang="en-US" altLang="ko-KR" sz="1100" kern="100" dirty="0"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6) </a:t>
            </a:r>
            <a:r>
              <a:rPr lang="en-US" altLang="ko-KR" sz="1100" kern="100" dirty="0">
                <a:effectLst/>
                <a:latin typeface="Times New Roman" panose="02020603050405020304" pitchFamily="18" charset="0"/>
                <a:ea typeface="맑은 고딕" panose="020B0503020000020004" pitchFamily="34" charset="-127"/>
                <a:cs typeface="Times New Roman" panose="02020603050405020304" pitchFamily="18" charset="0"/>
              </a:rPr>
              <a:t>(A) and from a healthy control (B). The droplets above the pink line, which is the threshold, are classified as positive (colored). Reactions with more than 8,000 droplets were considered valid.</a:t>
            </a:r>
            <a:endParaRPr lang="ko-KR" altLang="ko-KR" sz="1100" kern="100" dirty="0">
              <a:effectLst/>
              <a:latin typeface="Calibri" panose="020F0502020204030204" pitchFamily="34" charset="0"/>
              <a:ea typeface="맑은 고딕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37519D-A5FD-20A6-9EAD-FED078DD4E34}"/>
              </a:ext>
            </a:extLst>
          </p:cNvPr>
          <p:cNvSpPr txBox="1"/>
          <p:nvPr/>
        </p:nvSpPr>
        <p:spPr>
          <a:xfrm>
            <a:off x="8344456" y="208715"/>
            <a:ext cx="164019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ko-KR" sz="1400" i="1" dirty="0">
                <a:latin typeface="Arial" panose="020B0604020202020204" pitchFamily="34" charset="0"/>
                <a:cs typeface="Arial" panose="020B0604020202020204" pitchFamily="34" charset="0"/>
              </a:rPr>
              <a:t>PIK3CA</a:t>
            </a:r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wild-typ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7320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211</Words>
  <Application>Microsoft Macintosh PowerPoint</Application>
  <PresentationFormat>와이드스크린</PresentationFormat>
  <Paragraphs>11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승병준</dc:creator>
  <cp:lastModifiedBy>승병준</cp:lastModifiedBy>
  <cp:revision>11</cp:revision>
  <dcterms:created xsi:type="dcterms:W3CDTF">2024-07-26T06:05:21Z</dcterms:created>
  <dcterms:modified xsi:type="dcterms:W3CDTF">2024-10-13T19:01:28Z</dcterms:modified>
</cp:coreProperties>
</file>